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handoutMasterIdLst>
    <p:handoutMasterId r:id="rId12"/>
  </p:handoutMasterIdLst>
  <p:sldIdLst>
    <p:sldId id="285" r:id="rId2"/>
    <p:sldId id="273" r:id="rId3"/>
    <p:sldId id="284" r:id="rId4"/>
    <p:sldId id="260" r:id="rId5"/>
    <p:sldId id="262" r:id="rId6"/>
    <p:sldId id="264" r:id="rId7"/>
    <p:sldId id="286" r:id="rId8"/>
    <p:sldId id="265" r:id="rId9"/>
    <p:sldId id="271" r:id="rId10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arcia-Moreno, Marina" initials="GM" lastIdx="2" clrIdx="0"/>
  <p:cmAuthor id="2" name="Paul Jordan" initials="PJ" lastIdx="4" clrIdx="1">
    <p:extLst>
      <p:ext uri="{19B8F6BF-5375-455C-9EA6-DF929625EA0E}">
        <p15:presenceInfo xmlns:p15="http://schemas.microsoft.com/office/powerpoint/2012/main" userId="Paul Jord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855" autoAdjust="0"/>
  </p:normalViewPr>
  <p:slideViewPr>
    <p:cSldViewPr showGuides="1">
      <p:cViewPr varScale="1">
        <p:scale>
          <a:sx n="47" d="100"/>
          <a:sy n="47" d="100"/>
        </p:scale>
        <p:origin x="2172" y="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7DAC1-865B-4D31-B831-3A25A8AF22C2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2E3EF7-AAF9-47AD-8DFA-B4D4AAB2931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29643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F4D5F8-3E7C-47D2-88A6-BC1C74428ACB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728C84-3303-4297-BB39-299CE5CD50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8980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7302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1199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4736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7330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3164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4739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1331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9355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367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0108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4257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4C7E7-2037-4083-9CA3-904847C2456A}" type="datetimeFigureOut">
              <a:rPr lang="de-DE" smtClean="0"/>
              <a:t>07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477FF1-17B8-4368-AB03-0E14349D36F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7680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610423" y="70173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4005064" y="70314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88640" y="17951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S1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404664" y="4946300"/>
            <a:ext cx="596435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AU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1: Expression of virulence factors by </a:t>
            </a:r>
            <a:r>
              <a:rPr lang="en-AU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AU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I and SH1000.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AU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unctionality activity of </a:t>
            </a:r>
            <a:r>
              <a:rPr lang="en-AU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gr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s performed by analysing the haemolytic activities of 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olates on sheep blood agar plates. 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1 and SH1000 were tested by cross-streaking perpendicularly to 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N4220 on sheep blood agar plates. The clear zone at the intersection represent a high activity of </a:t>
            </a:r>
            <a:r>
              <a:rPr lang="en-AU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gr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3. The strain 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W2 and USA300 </a:t>
            </a:r>
            <a:r>
              <a:rPr lang="en-AU" sz="10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agr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re  used as positive and negative controls respectively. </a:t>
            </a:r>
            <a:r>
              <a:rPr lang="en-AU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of for </a:t>
            </a:r>
            <a:r>
              <a:rPr lang="en-AU" sz="10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sm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Relative expression of </a:t>
            </a:r>
            <a:r>
              <a:rPr lang="en-AU" sz="10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sm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o the housekeeping gene 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rB 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om </a:t>
            </a:r>
            <a:r>
              <a:rPr lang="en-AU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AU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S1 and SH1000 was analysed from in vitro culture after 5 hours of cultivation. Statistical comparison were performed by unpaired t-test *p &lt; 0.05; **p &lt; 0.01; ***p &lt; 0.001. The bars and whiskers represent the means ±SD of three independent experiments. </a:t>
            </a:r>
            <a:endParaRPr lang="en-AU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A01BE2EF-A196-A5E9-1909-B8742D293B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091" y="934187"/>
            <a:ext cx="2431313" cy="2644848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7073" y="1229521"/>
            <a:ext cx="1553649" cy="24061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77660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feld 12"/>
          <p:cNvSpPr txBox="1"/>
          <p:nvPr/>
        </p:nvSpPr>
        <p:spPr>
          <a:xfrm>
            <a:off x="610423" y="70173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005064" y="70314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8640" y="17951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S2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272962" y="3923928"/>
            <a:ext cx="5964350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2: Cell viability and invasion of osteoblasts and osteocytes by </a:t>
            </a:r>
            <a:r>
              <a:rPr lang="en-US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I and SH1000</a:t>
            </a:r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ability of osteoblasts and osteocytes cells (log live cells/ml) after infection with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1 and SH1000 and without bacteria;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3. </a:t>
            </a:r>
            <a:r>
              <a:rPr lang="en-GB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vasion of osteoblasts and osteocytes by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I and SH1000 strains after 90 min of infection (log CFU/10</a:t>
            </a:r>
            <a:r>
              <a:rPr lang="en-US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); Osteoblasts LS1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8, osteocytes LSI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6, osteoblasts SH1000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6 and osteocytes SH1000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3. Differences were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ed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using two-way and one-way ANOVA respectively, with Tukey’s multiple comparison test. No differences were found. The bars and whiskers represent the means ±SD of different independent experiments. -: uninfected cells and +: infected cells. </a:t>
            </a:r>
            <a:endParaRPr lang="de-DE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40" y="1245032"/>
            <a:ext cx="1600200" cy="1964436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0316" y="1251856"/>
            <a:ext cx="1534668" cy="1964436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483952F7-DEF1-03D0-B446-CA2127369B8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31" b="26745"/>
          <a:stretch/>
        </p:blipFill>
        <p:spPr>
          <a:xfrm>
            <a:off x="3717032" y="1115616"/>
            <a:ext cx="2427462" cy="23042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9179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88640" y="17951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S3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548680" y="3340894"/>
            <a:ext cx="576064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3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V formation of </a:t>
            </a:r>
            <a:r>
              <a:rPr lang="en-US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1 and SH1000 strains during persistence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covered SCVs from osteoblasts and osteocytes (log SCVs/10</a:t>
            </a:r>
            <a:r>
              <a:rPr lang="en-US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). Differences were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ed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using two-way ANOVA with Tukey’s multiple comparison test; ***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&lt;0.001, ****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&lt;0.0001. The bars and whiskers represent the means ±SD of independent experiments;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3.</a:t>
            </a:r>
            <a:endParaRPr lang="de-DE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4864" y="755577"/>
            <a:ext cx="1988820" cy="1811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52241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51970" y="1320618"/>
            <a:ext cx="893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steoblas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651970" y="1857327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steocyt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938439" y="1824609"/>
            <a:ext cx="893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steoblas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953666" y="1264215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steocyt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8640" y="17951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S4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593558" y="2619024"/>
            <a:ext cx="5760640" cy="10554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4: Representative scheme from a </a:t>
            </a:r>
            <a:r>
              <a:rPr lang="en-US" sz="10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incert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® in the top of a well during co-cultivatio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wo possible combinations used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teoblasts up in the insert and osteocytes down in the well;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teocytes up in the insert and osteoblasts down in the well</a:t>
            </a:r>
            <a:endParaRPr lang="de-DE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517618" y="46754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429000" y="46754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/>
          <a:srcRect t="28060"/>
          <a:stretch/>
        </p:blipFill>
        <p:spPr>
          <a:xfrm>
            <a:off x="1485564" y="814060"/>
            <a:ext cx="1804572" cy="1416637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t="26916"/>
          <a:stretch/>
        </p:blipFill>
        <p:spPr>
          <a:xfrm>
            <a:off x="3137443" y="813600"/>
            <a:ext cx="1803600" cy="1419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70862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787487" y="611560"/>
            <a:ext cx="8686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795742" y="611560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188640" y="17951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S5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548680" y="3422673"/>
            <a:ext cx="6048672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5: Persistence of </a:t>
            </a:r>
            <a:r>
              <a:rPr lang="en-US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1000 strain in co-cultivation system. (A)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g of intracellular bacteria recovered from infected osteoblasts and osteocytes at different time points during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well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eriments (osteoblasts up and osteocytes down. The results are expressed as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g CFU/10</a:t>
            </a:r>
            <a:r>
              <a:rPr lang="en-GB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GB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).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V formation in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well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eriments (log SCVs/10</a:t>
            </a:r>
            <a:r>
              <a:rPr lang="en-US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). Statistical analysis was performed using two-way ANOVA with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dak´s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ultiple comparison test and the unpaired t-test; **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&lt;0.01. The bars and whiskers represent the means ±SD of different independent experiments;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=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.</a:t>
            </a:r>
            <a:endParaRPr lang="de-DE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0664" y="947885"/>
            <a:ext cx="1234440" cy="1751907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487" y="749104"/>
            <a:ext cx="1776845" cy="1596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7474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88640" y="17951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S6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593558" y="3937448"/>
            <a:ext cx="5976664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6: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1000 strain recovered from conditioned medium experiment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odel of infection.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fected  Infected osteoblast cultured with control CM or infected CM were lysed and the numbers of intracellular bacteria were quantified by serial dilutions on blood agar plates (log CFU/10</a:t>
            </a:r>
            <a:r>
              <a:rPr lang="en-US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). Statistical analysis was performed using the unpaired t-test for each pair; *p&lt;0.1. The bars and whiskers represent the means ±SD of different independent experiments;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4 and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3 respectively. CM; conditioned medium.</a:t>
            </a:r>
            <a:endParaRPr lang="de-DE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132" y="1025593"/>
            <a:ext cx="1636568" cy="1779963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564161" y="509355"/>
            <a:ext cx="8686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804526" y="509355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846" y="751018"/>
            <a:ext cx="3819475" cy="2472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75587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188640" y="179512"/>
            <a:ext cx="28857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Oligonucleotides used for RT-PC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2496730"/>
              </p:ext>
            </p:extLst>
          </p:nvPr>
        </p:nvGraphicFramePr>
        <p:xfrm>
          <a:off x="260648" y="899592"/>
          <a:ext cx="5849620" cy="48101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969010">
                  <a:extLst>
                    <a:ext uri="{9D8B030D-6E8A-4147-A177-3AD203B41FA5}">
                      <a16:colId xmlns:a16="http://schemas.microsoft.com/office/drawing/2014/main" val="1110491657"/>
                    </a:ext>
                  </a:extLst>
                </a:gridCol>
                <a:gridCol w="2430145">
                  <a:extLst>
                    <a:ext uri="{9D8B030D-6E8A-4147-A177-3AD203B41FA5}">
                      <a16:colId xmlns:a16="http://schemas.microsoft.com/office/drawing/2014/main" val="1825340556"/>
                    </a:ext>
                  </a:extLst>
                </a:gridCol>
                <a:gridCol w="2450465">
                  <a:extLst>
                    <a:ext uri="{9D8B030D-6E8A-4147-A177-3AD203B41FA5}">
                      <a16:colId xmlns:a16="http://schemas.microsoft.com/office/drawing/2014/main" val="90916609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890376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yrB</a:t>
                      </a:r>
                      <a:endParaRPr lang="de-DE" sz="110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TGAAGCAGGCTATGTGT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GACCATTTTGGTGTTGG</a:t>
                      </a:r>
                      <a:endParaRPr lang="de-DE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89038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i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</a:t>
                      </a:r>
                      <a:r>
                        <a:rPr lang="en-GB" sz="10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de-DE" sz="110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ATTCACATGGAATTCGT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TAGCCATCGTTTTGTCCT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494771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470539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4847692"/>
              </p:ext>
            </p:extLst>
          </p:nvPr>
        </p:nvGraphicFramePr>
        <p:xfrm>
          <a:off x="951016" y="683568"/>
          <a:ext cx="5244792" cy="3422094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1550572">
                  <a:extLst>
                    <a:ext uri="{9D8B030D-6E8A-4147-A177-3AD203B41FA5}">
                      <a16:colId xmlns:a16="http://schemas.microsoft.com/office/drawing/2014/main" val="4102359534"/>
                    </a:ext>
                  </a:extLst>
                </a:gridCol>
                <a:gridCol w="957553">
                  <a:extLst>
                    <a:ext uri="{9D8B030D-6E8A-4147-A177-3AD203B41FA5}">
                      <a16:colId xmlns:a16="http://schemas.microsoft.com/office/drawing/2014/main" val="2826250277"/>
                    </a:ext>
                  </a:extLst>
                </a:gridCol>
                <a:gridCol w="1372857">
                  <a:extLst>
                    <a:ext uri="{9D8B030D-6E8A-4147-A177-3AD203B41FA5}">
                      <a16:colId xmlns:a16="http://schemas.microsoft.com/office/drawing/2014/main" val="1285369328"/>
                    </a:ext>
                  </a:extLst>
                </a:gridCol>
                <a:gridCol w="1363810">
                  <a:extLst>
                    <a:ext uri="{9D8B030D-6E8A-4147-A177-3AD203B41FA5}">
                      <a16:colId xmlns:a16="http://schemas.microsoft.com/office/drawing/2014/main" val="344680601"/>
                    </a:ext>
                  </a:extLst>
                </a:gridCol>
              </a:tblGrid>
              <a:tr h="8640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 (cells/ml) Before 2</a:t>
                      </a:r>
                      <a:r>
                        <a:rPr lang="en-US" sz="10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fection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 (cells/ml) After 90 min of the 2</a:t>
                      </a:r>
                      <a:r>
                        <a:rPr lang="en-US" sz="10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fection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parison between control and conditioned cells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b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npaired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t-test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2222303"/>
                  </a:ext>
                </a:extLst>
              </a:tr>
              <a:tr h="34203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blast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63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82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4313940"/>
                  </a:ext>
                </a:extLst>
              </a:tr>
              <a:tr h="28803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ected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blast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98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35</a:t>
                      </a:r>
                      <a:endParaRPr lang="en-US" sz="1000" b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71187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cyte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55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55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6809977"/>
                  </a:ext>
                </a:extLst>
              </a:tr>
              <a:tr h="31589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ected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cyte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00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55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3712689"/>
                  </a:ext>
                </a:extLst>
              </a:tr>
              <a:tr h="28803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cyte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04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60</a:t>
                      </a:r>
                      <a:endParaRPr lang="en-US" sz="1000" b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9255505"/>
                  </a:ext>
                </a:extLst>
              </a:tr>
              <a:tr h="28803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cyte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48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84</a:t>
                      </a:r>
                      <a:endParaRPr lang="en-US" sz="1000" b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6496511"/>
                  </a:ext>
                </a:extLst>
              </a:tr>
              <a:tr h="28803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blast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84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88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5817972"/>
                  </a:ext>
                </a:extLst>
              </a:tr>
              <a:tr h="3879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baseline="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steoblasts</a:t>
                      </a:r>
                      <a:r>
                        <a:rPr lang="de-DE" sz="1000" b="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M</a:t>
                      </a:r>
                      <a:endParaRPr lang="en-US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232" marR="64232" marT="8921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50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35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9908745"/>
                  </a:ext>
                </a:extLst>
              </a:tr>
            </a:tbl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0288626"/>
              </p:ext>
            </p:extLst>
          </p:nvPr>
        </p:nvGraphicFramePr>
        <p:xfrm>
          <a:off x="548680" y="1558733"/>
          <a:ext cx="402336" cy="1296144"/>
        </p:xfrm>
        <a:graphic>
          <a:graphicData uri="http://schemas.openxmlformats.org/drawingml/2006/table">
            <a:tbl>
              <a:tblPr/>
              <a:tblGrid>
                <a:gridCol w="402336">
                  <a:extLst>
                    <a:ext uri="{9D8B030D-6E8A-4147-A177-3AD203B41FA5}">
                      <a16:colId xmlns:a16="http://schemas.microsoft.com/office/drawing/2014/main" val="1608550809"/>
                    </a:ext>
                  </a:extLst>
                </a:gridCol>
              </a:tblGrid>
              <a:tr h="1296144">
                <a:tc>
                  <a:txBody>
                    <a:bodyPr/>
                    <a:lstStyle/>
                    <a:p>
                      <a:pPr algn="ctr"/>
                      <a:r>
                        <a:rPr lang="de-DE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oblasts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78488560"/>
                  </a:ext>
                </a:extLst>
              </a:tr>
            </a:tbl>
          </a:graphicData>
        </a:graphic>
      </p:graphicFrame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3372473"/>
              </p:ext>
            </p:extLst>
          </p:nvPr>
        </p:nvGraphicFramePr>
        <p:xfrm>
          <a:off x="548680" y="2854876"/>
          <a:ext cx="402336" cy="1261854"/>
        </p:xfrm>
        <a:graphic>
          <a:graphicData uri="http://schemas.openxmlformats.org/drawingml/2006/table">
            <a:tbl>
              <a:tblPr/>
              <a:tblGrid>
                <a:gridCol w="402336">
                  <a:extLst>
                    <a:ext uri="{9D8B030D-6E8A-4147-A177-3AD203B41FA5}">
                      <a16:colId xmlns:a16="http://schemas.microsoft.com/office/drawing/2014/main" val="1608550809"/>
                    </a:ext>
                  </a:extLst>
                </a:gridCol>
              </a:tblGrid>
              <a:tr h="126185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ocytes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dirty="0"/>
                    </a:p>
                  </a:txBody>
                  <a:tcPr vert="vert27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78488560"/>
                  </a:ext>
                </a:extLst>
              </a:tr>
            </a:tbl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188640" y="179512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2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404664" y="4283968"/>
            <a:ext cx="5832648" cy="12756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1" algn="just">
              <a:lnSpc>
                <a:spcPct val="200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2. Viability of cells at different time points from all combinations (</a:t>
            </a:r>
            <a:r>
              <a:rPr lang="en-US" sz="10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well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eriments)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Control and infected CM cells were counted before and after second infection was done with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S1. Statistical analysis was performed using the unpaired t-test;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5. CM; conditioned medium, NS; non-significant.</a:t>
            </a:r>
            <a:endParaRPr lang="de-DE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17949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188640" y="179512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6: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426912" y="5220072"/>
            <a:ext cx="6192688" cy="967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6: </a:t>
            </a:r>
            <a:r>
              <a:rPr lang="en-US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vokes differential lipid mediator (LM) pathways in osteoblasts and osteocytes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tracted LMs were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ed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UPLC-MS-MS and are shown as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g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10</a:t>
            </a:r>
            <a:r>
              <a:rPr lang="en-US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, given as means ± S.E.M. and as fold-increase (F</a:t>
            </a:r>
            <a:r>
              <a:rPr lang="en-US" sz="10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f LM against medium;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= 6.</a:t>
            </a:r>
            <a:endParaRPr lang="de-DE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81F6E1E7-AD00-49DD-8F1B-8675257C8C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612" y="899592"/>
            <a:ext cx="5661227" cy="4220304"/>
          </a:xfrm>
          <a:prstGeom prst="rect">
            <a:avLst/>
          </a:prstGeom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id="{67CA2BF9-3361-4A3F-8FA7-380D95C491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612" y="953110"/>
            <a:ext cx="1002315" cy="261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275770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7</Words>
  <Application>Microsoft Office PowerPoint</Application>
  <PresentationFormat>On-screen Show (4:3)</PresentationFormat>
  <Paragraphs>7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Lariss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arcia-Moreno, Marina</dc:creator>
  <cp:lastModifiedBy>Laura Goodfellow</cp:lastModifiedBy>
  <cp:revision>126</cp:revision>
  <cp:lastPrinted>2021-10-19T05:49:01Z</cp:lastPrinted>
  <dcterms:created xsi:type="dcterms:W3CDTF">2021-03-04T10:38:22Z</dcterms:created>
  <dcterms:modified xsi:type="dcterms:W3CDTF">2022-07-07T12:14:14Z</dcterms:modified>
</cp:coreProperties>
</file>